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52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BAF1B-8278-4964-8818-C3796EA16070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DF3BBB-7FD9-4036-AE15-C233E8AF1C6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707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298DA-4F9D-FAB2-55BD-C269AC2448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65E7CA-9FFA-51F4-B1C5-7214D878A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F958F-B6D1-9A72-E9BA-9E9B5B993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9A2D0-29B0-5F3A-486A-02CCCD149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3E381-EB1E-8E1F-FAB5-3ECC6A8EB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5312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808E3-A445-6A11-4982-806D4762C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6A17FA-3F31-FEF1-E659-2FC177F38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B808-7EE6-79D1-4EC6-48CB7E36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FB91E-9783-71B5-5334-D92E19A06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14E817-30B4-520C-1690-086E8F36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089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A0F1D4-5775-1B04-CFFC-C7F2950BA2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BDC13-DC96-76A1-BA85-92774A449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E3F4A-5D4A-82F6-B088-76774B12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82726-B54D-C789-9EB6-315260C1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1A568-59BC-DE07-B3CA-DF0329F2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4164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700CA-9D9D-D055-60B3-A22ED4D20D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84BDE2-3086-AB6A-9408-880C25FAA8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70C87-08D0-58A1-0424-4B433948F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7E87E8-FB71-B969-2273-90F6E9A93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2FBBF-3FC1-E20D-99B2-83EB1E9BE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506355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EB206-2AEC-B948-2146-383DC007CD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2F63C6-5895-7307-3180-FD1C07B5F2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EC45C2-C6C7-EF8E-A2CD-84B242D34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FBACF1-0745-4356-F4FA-7AD9E0207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C50FC-AFDE-2213-19CE-91BBEBEDB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2759031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70C97-1C76-A977-3822-B326E8B66E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B6A869-B5D2-6427-BB60-25222A1A80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18C2CE-9537-1AC2-CB38-FD1C77747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77161F-B52D-D36B-35AA-ACA319BF2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492CB6-C9CD-A851-4DC1-CE9EFADDA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985054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E83F5-03BE-679B-AD8C-BD7C779C6D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0FC1EE-1D7A-0965-3DC6-8C1452ACDE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C85599-D62F-07EB-D396-1A980E898A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E821E6-50A9-4E17-1153-259946383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49E6B7-094B-37FA-5863-54FEBBA79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128417-BD7F-2456-CBBC-74B8F2156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369279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CA3AC-0B7A-B1C4-8D1D-2A4757610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DBA412-11E6-AEBB-D438-83C1556F01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B1C1A3-15D5-D785-F2C8-0A62CB879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45A60D-C8C2-C3BC-0D01-AEECFF32F4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8EDBB7-6AAC-2B36-EC95-C601675996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8C793B-1D9B-E141-AF81-3A47985C8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F1DF57-53D1-CE63-817D-73779343F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58D02C-98BF-2CF7-67CF-12163C65A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1575107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8D2D1-11D5-0394-3CAC-33106C011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E6445A-C590-2009-7525-D729C04AC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ED1844-021D-61D6-F284-D894DEA08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1B1474-546A-7D96-3FA8-D4D4FC6FE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4253355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9A1390-81E0-2504-0893-E147919CC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AE209D-CD0C-707C-76A8-A63D7158E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04F703-222F-37D5-30CD-D613510EF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287069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06B24-E865-F183-83CB-DDE013D3B6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167C77-7233-F214-7440-C794B0FE2E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D4BE6F-3CA2-E4A5-6641-13B5E62B71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277DC3-11CC-9DE7-E35B-A9C410B46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8B3FB8-4C8B-1F7A-6B3A-9B9F40408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2B823F-DF56-38DE-D52D-3DC433F30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87284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930CB-4AE0-032A-5692-D81CA12F2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A7FABA-8B01-B134-9CF9-4E26B8828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D0B9D-3798-7D50-9702-AAEA4AC7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5ADFA-856E-E343-89AC-7D88E015E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3788B-D56B-0304-8079-8D1AB6C5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10772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791163-909A-6A22-6AE1-282ACAC67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23FE12-701F-6B1A-6297-3A481DEC89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19E3B3-0883-EB71-A8D2-E1271A2FE4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8A2C61-8802-EE23-A9C0-2F43B7734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0730DA-3B75-FFCF-20E6-28698194A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51B565-9A02-652E-900B-5DA5CA047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860721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8725D-7E42-E7BA-6D3C-CCBE7FE65D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4A5F4C-6886-F096-AB27-2E8B63F448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A9F8EF-7FD9-F347-FD67-1964E399C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056B90-78C1-BFC3-3FCB-839B4FDD9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6521D2-409B-419D-AAB1-4812148BD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084437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448FC25-0699-18BD-1E05-462A8BB3B5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A2BAE6-ACE8-A171-77BD-A7C6323CAF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EF4C47-3E0F-49FA-53BF-FB951A2E4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E189CA-9C2C-C60A-DF0A-BA1230A19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3B2EE-BA4F-84BE-C5BD-5E952B8E1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548426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21"/>
          </p:nvPr>
        </p:nvSpPr>
        <p:spPr>
          <a:xfrm>
            <a:off x="6248408" y="-742950"/>
            <a:ext cx="5096935" cy="7645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895359" y="1822451"/>
            <a:ext cx="5003801" cy="4419600"/>
          </a:xfrm>
          <a:prstGeom prst="rect">
            <a:avLst/>
          </a:prstGeom>
        </p:spPr>
        <p:txBody>
          <a:bodyPr/>
          <a:lstStyle>
            <a:lvl1pPr marL="215887" indent="-215887">
              <a:spcBef>
                <a:spcPts val="2651"/>
              </a:spcBef>
              <a:defRPr sz="1900"/>
            </a:lvl1pPr>
            <a:lvl2pPr marL="431774" indent="-215887">
              <a:spcBef>
                <a:spcPts val="2651"/>
              </a:spcBef>
              <a:defRPr sz="1900"/>
            </a:lvl2pPr>
            <a:lvl3pPr marL="647662" indent="-215887">
              <a:spcBef>
                <a:spcPts val="2651"/>
              </a:spcBef>
              <a:defRPr sz="1900"/>
            </a:lvl3pPr>
            <a:lvl4pPr marL="863547" indent="-215887">
              <a:spcBef>
                <a:spcPts val="2651"/>
              </a:spcBef>
              <a:defRPr sz="1900"/>
            </a:lvl4pPr>
            <a:lvl5pPr marL="1079432" indent="-215887">
              <a:spcBef>
                <a:spcPts val="2651"/>
              </a:spcBef>
              <a:defRPr sz="19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 anchor="t"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74515130"/>
      </p:ext>
    </p:extLst>
  </p:cSld>
  <p:clrMapOvr>
    <a:masterClrMapping/>
  </p:clrMapOvr>
  <p:transition spd="med"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25920124"/>
      </p:ext>
    </p:extLst>
  </p:cSld>
  <p:clrMapOvr>
    <a:masterClrMapping/>
  </p:clrMapOvr>
  <p:transition spd="med"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 anchor="t"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630267724"/>
      </p:ext>
    </p:extLst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39C7D-F2D6-A4E0-A0D8-583061111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B438E-7CEF-E9C3-60D9-B9D0999CD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F4D46-8B70-35E8-07AB-DC394C35A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3931-F308-55A0-1B60-0AD15111D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45DCF-EFA4-37E3-991F-0159E67C7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4736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1EBB-D829-0E9D-8A37-888BBB200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CC76F3-0F10-5DFA-B62C-939F1BD20B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333A63-9B12-2DEB-2CE1-1AE3547EAD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F5DEF-57A7-FA35-0DE6-487FB3514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1536-D74D-842D-621A-5DD1AF3F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E2F49F-45E9-DA7D-E967-A5E00E62E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25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EFBBF-F17F-12F4-E4C1-088DE060A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752EF-2A68-01E3-61A8-94BA0FEBD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877A6D-E365-ADAC-1A07-B82768F68D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3654B6-6CFE-61B2-3A16-AD648BBBC5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15FC14-2C18-1DD9-9060-5FB267AF9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1FB786-0028-A983-B6CE-5EE067E5D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0582CD-B2E0-CBFC-BBE2-19EA86655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00D54-0235-9CF2-1A29-9FD01E7F0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84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369CD-4D23-8BFC-A542-2B92D890B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D21CBA-51F0-88AD-F604-832CE87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D55CA-98E7-46CF-7AB4-AFABA0973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2784CE-83CC-2EAC-9FEB-ACC3B17B7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013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040D52-7C1E-AB1D-798F-8BAE652C9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FFA8C7-33F2-02E5-7D2A-C0D1D7722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02132B-E01A-6E46-F0F2-9273B9525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927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D4B46-A811-C07C-A508-0DF86A2E8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E3D39-C1C6-B4B2-94B5-E3AD251DAB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304D2-5DEA-1878-EA86-1275E25F1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E57E76-31E0-7F8D-E1F8-C0DAF968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6A111-82FD-9CDC-74BA-FBE7EE29F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1F2276-3ABC-51F8-BAED-E0F6F46D1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3459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8B00F-6894-5048-42F0-6537E501A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E7382-68F0-8ADD-E54A-F075972BD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FB87C-D120-E599-35B8-DC76CD239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E7358D-B640-B4AE-D58C-6E698B07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29F8AA-1B45-7650-EE90-858F206DB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B9F684-B59A-4A16-4297-6850B3B0A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482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theme" Target="../theme/theme2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F27173-DD36-2C49-9885-E5F44228A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987A0-A5C9-B390-BE4B-D4F17764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FF9C0-7219-1D1E-A1D4-A43C84BD6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E0F85-0C1B-BA21-BF4A-39B26F1240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91B6E6-E829-B6B3-FBEE-083D5C9CC2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9029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5BF267-AB9B-C47C-04ED-DA6591DFB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A77420-6536-ECAD-6F23-CACB0A52CB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2D4BD0-199B-0611-8714-B711A89260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03198A-F56D-A46F-A520-A1BBDEB98E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F18B4F-5177-34A5-8974-C74C0B8A45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3800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1CD3D139-38B4-9344-916C-7C623271A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 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5C8983-AE08-C34D-B7A3-B8032567A4A0}"/>
              </a:ext>
            </a:extLst>
          </p:cNvPr>
          <p:cNvSpPr>
            <a:spLocks noGrp="1"/>
          </p:cNvSpPr>
          <p:nvPr>
            <p:ph type="body" sz="half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F4E774C-C127-794F-A844-76AFB084BA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86026" y="584175"/>
            <a:ext cx="11639059" cy="5657876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ECC220D7-5591-9F48-B884-04047F46FB47}"/>
              </a:ext>
            </a:extLst>
          </p:cNvPr>
          <p:cNvCxnSpPr>
            <a:cxnSpLocks/>
          </p:cNvCxnSpPr>
          <p:nvPr/>
        </p:nvCxnSpPr>
        <p:spPr>
          <a:xfrm flipH="1">
            <a:off x="830720" y="3502407"/>
            <a:ext cx="469138" cy="64727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76E6428D-DB0E-604F-854F-1C5096150352}"/>
              </a:ext>
            </a:extLst>
          </p:cNvPr>
          <p:cNvSpPr txBox="1"/>
          <p:nvPr/>
        </p:nvSpPr>
        <p:spPr>
          <a:xfrm>
            <a:off x="971319" y="3196670"/>
            <a:ext cx="1827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V Light-Meter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2F398868-BC44-A945-B391-E945BCF6E92F}"/>
              </a:ext>
            </a:extLst>
          </p:cNvPr>
          <p:cNvCxnSpPr>
            <a:cxnSpLocks/>
          </p:cNvCxnSpPr>
          <p:nvPr/>
        </p:nvCxnSpPr>
        <p:spPr>
          <a:xfrm flipV="1">
            <a:off x="5665076" y="4316053"/>
            <a:ext cx="678658" cy="29343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8A93C22-9186-9540-9810-B7736AF45B78}"/>
              </a:ext>
            </a:extLst>
          </p:cNvPr>
          <p:cNvSpPr txBox="1"/>
          <p:nvPr/>
        </p:nvSpPr>
        <p:spPr>
          <a:xfrm>
            <a:off x="5182355" y="4604701"/>
            <a:ext cx="1827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bre Optic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5DCA4C30-0D64-EA41-9EC3-723B3BFBF752}"/>
              </a:ext>
            </a:extLst>
          </p:cNvPr>
          <p:cNvCxnSpPr>
            <a:cxnSpLocks/>
          </p:cNvCxnSpPr>
          <p:nvPr/>
        </p:nvCxnSpPr>
        <p:spPr>
          <a:xfrm flipH="1" flipV="1">
            <a:off x="9012621" y="1246318"/>
            <a:ext cx="913645" cy="57613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3E54E34-B04A-F24D-B8AF-2EC45562AE02}"/>
              </a:ext>
            </a:extLst>
          </p:cNvPr>
          <p:cNvSpPr txBox="1"/>
          <p:nvPr/>
        </p:nvSpPr>
        <p:spPr>
          <a:xfrm>
            <a:off x="9526511" y="1818895"/>
            <a:ext cx="1827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V Light Source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0C329303-0B20-7A43-9445-AE86F4C13325}"/>
              </a:ext>
            </a:extLst>
          </p:cNvPr>
          <p:cNvCxnSpPr>
            <a:cxnSpLocks/>
          </p:cNvCxnSpPr>
          <p:nvPr/>
        </p:nvCxnSpPr>
        <p:spPr>
          <a:xfrm flipV="1">
            <a:off x="4424855" y="3058510"/>
            <a:ext cx="662152" cy="830318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019077BD-79F5-3B45-A555-AE91459FEE7C}"/>
              </a:ext>
            </a:extLst>
          </p:cNvPr>
          <p:cNvSpPr txBox="1"/>
          <p:nvPr/>
        </p:nvSpPr>
        <p:spPr>
          <a:xfrm>
            <a:off x="3975328" y="3888828"/>
            <a:ext cx="1827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atheter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6143A7D-53D7-3044-B397-AD3D185D4AAE}"/>
              </a:ext>
            </a:extLst>
          </p:cNvPr>
          <p:cNvCxnSpPr>
            <a:cxnSpLocks/>
          </p:cNvCxnSpPr>
          <p:nvPr/>
        </p:nvCxnSpPr>
        <p:spPr>
          <a:xfrm flipH="1" flipV="1">
            <a:off x="7601858" y="2138677"/>
            <a:ext cx="672663" cy="52988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B83F0417-20A0-144B-8244-1464D6FB22C6}"/>
              </a:ext>
            </a:extLst>
          </p:cNvPr>
          <p:cNvSpPr txBox="1"/>
          <p:nvPr/>
        </p:nvSpPr>
        <p:spPr>
          <a:xfrm>
            <a:off x="8098977" y="2646337"/>
            <a:ext cx="1827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W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AA6935BD-5F36-BA4A-AD3C-B9D3212E38C6}"/>
              </a:ext>
            </a:extLst>
          </p:cNvPr>
          <p:cNvCxnSpPr>
            <a:cxnSpLocks/>
          </p:cNvCxnSpPr>
          <p:nvPr/>
        </p:nvCxnSpPr>
        <p:spPr>
          <a:xfrm>
            <a:off x="5500257" y="2066932"/>
            <a:ext cx="1210598" cy="440002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AA6A136D-93FF-3943-B92B-2D4D183AB533}"/>
              </a:ext>
            </a:extLst>
          </p:cNvPr>
          <p:cNvSpPr txBox="1"/>
          <p:nvPr/>
        </p:nvSpPr>
        <p:spPr>
          <a:xfrm>
            <a:off x="5087007" y="1840836"/>
            <a:ext cx="1827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alloo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6634214-5B3A-F84C-A033-176B4634BC6C}"/>
              </a:ext>
            </a:extLst>
          </p:cNvPr>
          <p:cNvSpPr txBox="1"/>
          <p:nvPr/>
        </p:nvSpPr>
        <p:spPr>
          <a:xfrm>
            <a:off x="5500257" y="3323181"/>
            <a:ext cx="1827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V Sensor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B240EEBB-9A99-5045-BD25-0929B4D82302}"/>
              </a:ext>
            </a:extLst>
          </p:cNvPr>
          <p:cNvCxnSpPr>
            <a:cxnSpLocks/>
          </p:cNvCxnSpPr>
          <p:nvPr/>
        </p:nvCxnSpPr>
        <p:spPr>
          <a:xfrm flipV="1">
            <a:off x="5984633" y="2633965"/>
            <a:ext cx="858539" cy="642177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EFF8806C-78A5-2248-88C2-027F554C7109}"/>
              </a:ext>
            </a:extLst>
          </p:cNvPr>
          <p:cNvSpPr txBox="1"/>
          <p:nvPr/>
        </p:nvSpPr>
        <p:spPr>
          <a:xfrm>
            <a:off x="3918912" y="60072"/>
            <a:ext cx="3942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nline Resource 4a</a:t>
            </a:r>
          </a:p>
        </p:txBody>
      </p:sp>
    </p:spTree>
    <p:extLst>
      <p:ext uri="{BB962C8B-B14F-4D97-AF65-F5344CB8AC3E}">
        <p14:creationId xmlns:p14="http://schemas.microsoft.com/office/powerpoint/2010/main" val="4259614596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17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1_Office Theme</vt:lpstr>
      <vt:lpstr>  </vt:lpstr>
    </vt:vector>
  </TitlesOfParts>
  <Company>Monas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Dear</dc:creator>
  <cp:lastModifiedBy>Anthony Dear</cp:lastModifiedBy>
  <cp:revision>5</cp:revision>
  <dcterms:created xsi:type="dcterms:W3CDTF">2023-01-04T23:35:19Z</dcterms:created>
  <dcterms:modified xsi:type="dcterms:W3CDTF">2023-01-05T00:22:52Z</dcterms:modified>
</cp:coreProperties>
</file>